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9240" autoAdjust="0"/>
  </p:normalViewPr>
  <p:slideViewPr>
    <p:cSldViewPr>
      <p:cViewPr varScale="1">
        <p:scale>
          <a:sx n="60" d="100"/>
          <a:sy n="60" d="100"/>
        </p:scale>
        <p:origin x="2098" y="3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9C44D8-C92D-45AE-A3DA-A1723A40C5A7}" type="datetimeFigureOut">
              <a:rPr lang="en-US" smtClean="0"/>
              <a:t>11/4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9D2E63-BC77-483B-A8BD-FB4B925FEB6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9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prominent GAPDH (G) protein spo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two Cdc48-like (Cd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two coronin (Cor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which were detected as significantl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in fluorescent gel images of the attenuated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prominent GAPDH (G) and the two Cdc48-like (Cd) protein spots found to be overexpressed by the 2D-DIGE-α experiment were marked on the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presentative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additionally on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wo coronin (Cor) protein spots and a similar prominent GAPDH (G) spot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In the first dimension proteins were separated using 18 cm IPG strips with a pH range 4-7 and in the second dimension by using 10% polyacrylamide gel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arentheses provide the spot IDs, which were assigned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harvested at passage number 303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a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extracted from 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on day 1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300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labeled with G-Dye 30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Cdc48-lik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cell division cycle protein 48-lik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9D2E63-BC77-483B-A8BD-FB4B925FEB62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 lnSpcReduction="10000"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9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prominent GAPDH (G) protein spo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two Cdc48-like (Cd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two coronin (Cor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which were detected as significantl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in fluorescent gel images of the attenuated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prominent GAPDH (G) and the two Cdc48-like (Cd) protein spots found to be overexpressed by the 2D-DIGE-α experiment were marked on the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presentative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additionally on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wo coronin (Cor) protein spots and a similar prominent GAPDH (G) spot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In the first dimension proteins were separated using 18 cm IPG strips with a pH range 4-7 and in the second dimension by using 10% polyacrylamide gel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arentheses provide the spot IDs, which were assigned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harvested at passage number 303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a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extracted from 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on day 1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300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labeled with G-Dye 30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Cdc48-lik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cell division cycle protein 48-lik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  <a:p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9D2E63-BC77-483B-A8BD-FB4B925FEB6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3596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9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prominent GAPDH (G) protein spo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two Cdc48-like (Cd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two coronin (Cor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which were detected as significantl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in fluorescent gel images of the attenuated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prominent GAPDH (G) and the two Cdc48-like (Cd) protein spots found to be overexpressed by the 2D-DIGE-α experiment were marked on the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presentative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additionally on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wo coronin (Cor) protein spots and a similar prominent GAPDH (G) spot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In the first dimension proteins were separated using 18 cm IPG strips with a pH range 4-7 and in the second dimension by using 10% polyacrylamide gel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arentheses provide the spot IDs, which were assigned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harvested at passage number 303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a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extracted from 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on day 1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300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labeled with G-Dye 30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Cdc48-lik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cell division cycle protein 48-lik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9D2E63-BC77-483B-A8BD-FB4B925FEB6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5634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9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prominent GAPDH (G) protein spot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, 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two Cdc48-like (Cd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two coronin (Cor) protein spots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, which were detected as significantly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in fluorescent gel images of the attenuated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prominent GAPDH (G) and the two Cdc48-like (Cd) protein spots found to be overexpressed by the 2D-DIGE-α experiment were marked on the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epresentative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additionally on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2-303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wo coronin (Cor) protein spots and a similar prominent GAPDH (G) spot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In the first dimension proteins were separated using 18 cm IPG strips with a pH range 4-7 and in the second dimension by using 10% polyacrylamide gel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he parentheses provide the spot IDs, which were assigned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harvested at passage number 303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03a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extracted from attenuate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arasites on day 1;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G300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rotein samples labeled with G-Dye 300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Cdc48-lik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cell division cycle protein 48-lik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</a:t>
            </a:r>
            <a:r>
              <a: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9D2E63-BC77-483B-A8BD-FB4B925FEB6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881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ieren 17"/>
          <p:cNvGrpSpPr/>
          <p:nvPr/>
        </p:nvGrpSpPr>
        <p:grpSpPr>
          <a:xfrm>
            <a:off x="1511232" y="-288000"/>
            <a:ext cx="7596768" cy="5692466"/>
            <a:chOff x="1511232" y="-288000"/>
            <a:chExt cx="7596768" cy="5692466"/>
          </a:xfrm>
        </p:grpSpPr>
        <p:pic>
          <p:nvPicPr>
            <p:cNvPr id="12" name="Grafik 11" descr="Cdc48 and GAPDH atteDIGEA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583240" y="251248"/>
              <a:ext cx="5760000" cy="470499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42" name="Textfeld 41"/>
            <p:cNvSpPr txBox="1"/>
            <p:nvPr/>
          </p:nvSpPr>
          <p:spPr>
            <a:xfrm>
              <a:off x="1511232" y="-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732000" y="-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4463560" y="-288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5580000" y="-3600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2987824" y="4912023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c48-like (</a:t>
              </a:r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l2-303a-G300</a:t>
              </a:r>
            </a:p>
          </p:txBody>
        </p:sp>
        <p:cxnSp>
          <p:nvCxnSpPr>
            <p:cNvPr id="15" name="Gerade Verbindung mit Pfeil 14"/>
            <p:cNvCxnSpPr/>
            <p:nvPr/>
          </p:nvCxnSpPr>
          <p:spPr>
            <a:xfrm flipH="1">
              <a:off x="6876000" y="2447992"/>
              <a:ext cx="720000" cy="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/>
            <p:cNvSpPr txBox="1"/>
            <p:nvPr/>
          </p:nvSpPr>
          <p:spPr>
            <a:xfrm>
              <a:off x="7524000" y="2304000"/>
              <a:ext cx="15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509)</a:t>
              </a:r>
            </a:p>
          </p:txBody>
        </p:sp>
        <p:cxnSp>
          <p:nvCxnSpPr>
            <p:cNvPr id="14" name="Gerade Verbindung mit Pfeil 13"/>
            <p:cNvCxnSpPr/>
            <p:nvPr/>
          </p:nvCxnSpPr>
          <p:spPr>
            <a:xfrm flipH="1">
              <a:off x="4327200" y="548680"/>
              <a:ext cx="388816" cy="584448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mit Pfeil 12"/>
            <p:cNvCxnSpPr/>
            <p:nvPr/>
          </p:nvCxnSpPr>
          <p:spPr>
            <a:xfrm>
              <a:off x="3779912" y="548680"/>
              <a:ext cx="468088" cy="576064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feld 18"/>
            <p:cNvSpPr txBox="1"/>
            <p:nvPr/>
          </p:nvSpPr>
          <p:spPr>
            <a:xfrm>
              <a:off x="4644008" y="332656"/>
              <a:ext cx="16916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274)</a:t>
              </a: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024000" y="324000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266)</a:t>
              </a:r>
            </a:p>
          </p:txBody>
        </p:sp>
      </p:grpSp>
      <p:sp>
        <p:nvSpPr>
          <p:cNvPr id="21" name="Textfeld 20"/>
          <p:cNvSpPr txBox="1"/>
          <p:nvPr/>
        </p:nvSpPr>
        <p:spPr>
          <a:xfrm>
            <a:off x="971600" y="-27384"/>
            <a:ext cx="3957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</a:p>
        </p:txBody>
      </p:sp>
      <p:sp>
        <p:nvSpPr>
          <p:cNvPr id="22" name="Rectangle 1">
            <a:extLst>
              <a:ext uri="{FF2B5EF4-FFF2-40B4-BE49-F238E27FC236}">
                <a16:creationId xmlns:a16="http://schemas.microsoft.com/office/drawing/2014/main" id="{98F54B93-C523-4803-987E-F4B7BDF0D2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159CBE5E-9F61-44B1-90CC-406E6B123163}"/>
              </a:ext>
            </a:extLst>
          </p:cNvPr>
          <p:cNvCxnSpPr>
            <a:cxnSpLocks/>
          </p:cNvCxnSpPr>
          <p:nvPr/>
        </p:nvCxnSpPr>
        <p:spPr>
          <a:xfrm>
            <a:off x="1584000" y="198000"/>
            <a:ext cx="57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2794243-0CAC-4061-BC72-F763BD4CB9BB}"/>
              </a:ext>
            </a:extLst>
          </p:cNvPr>
          <p:cNvCxnSpPr/>
          <p:nvPr/>
        </p:nvCxnSpPr>
        <p:spPr>
          <a:xfrm>
            <a:off x="1512000" y="252000"/>
            <a:ext cx="0" cy="4716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4C611CE8-C029-4E40-84C0-A583BBC4D57F}"/>
              </a:ext>
            </a:extLst>
          </p:cNvPr>
          <p:cNvSpPr/>
          <p:nvPr/>
        </p:nvSpPr>
        <p:spPr>
          <a:xfrm>
            <a:off x="1103982" y="235220"/>
            <a:ext cx="3978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4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n-GB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uppieren 55"/>
          <p:cNvGrpSpPr/>
          <p:nvPr/>
        </p:nvGrpSpPr>
        <p:grpSpPr>
          <a:xfrm>
            <a:off x="1116000" y="-180000"/>
            <a:ext cx="8028000" cy="5685619"/>
            <a:chOff x="1116000" y="-180000"/>
            <a:chExt cx="8028000" cy="5685619"/>
          </a:xfrm>
        </p:grpSpPr>
        <p:sp>
          <p:nvSpPr>
            <p:cNvPr id="5" name="Textfeld 4"/>
            <p:cNvSpPr txBox="1"/>
            <p:nvPr/>
          </p:nvSpPr>
          <p:spPr>
            <a:xfrm>
              <a:off x="1656000" y="72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912000" y="72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392000" y="-180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652000" y="7200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3275856" y="5013176"/>
              <a:ext cx="2952328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c48-like (</a:t>
              </a:r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lver-stained Gel 2</a:t>
              </a:r>
            </a:p>
          </p:txBody>
        </p:sp>
        <p:pic>
          <p:nvPicPr>
            <p:cNvPr id="32" name="Grafik 31" descr="Gel2 2nd DIGE A silver-stain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92000" y="331200"/>
              <a:ext cx="5760640" cy="4680520"/>
            </a:xfrm>
            <a:prstGeom prst="rect">
              <a:avLst/>
            </a:prstGeom>
          </p:spPr>
        </p:pic>
        <p:cxnSp>
          <p:nvCxnSpPr>
            <p:cNvPr id="35" name="Gerade Verbindung 34"/>
            <p:cNvCxnSpPr/>
            <p:nvPr/>
          </p:nvCxnSpPr>
          <p:spPr>
            <a:xfrm>
              <a:off x="1439672" y="53418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35"/>
            <p:cNvCxnSpPr/>
            <p:nvPr/>
          </p:nvCxnSpPr>
          <p:spPr>
            <a:xfrm>
              <a:off x="1439672" y="93014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36"/>
            <p:cNvCxnSpPr/>
            <p:nvPr/>
          </p:nvCxnSpPr>
          <p:spPr>
            <a:xfrm>
              <a:off x="1440000" y="1404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37"/>
            <p:cNvCxnSpPr/>
            <p:nvPr/>
          </p:nvCxnSpPr>
          <p:spPr>
            <a:xfrm>
              <a:off x="1439672" y="1850619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1439672" y="2384872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39"/>
            <p:cNvCxnSpPr/>
            <p:nvPr/>
          </p:nvCxnSpPr>
          <p:spPr>
            <a:xfrm>
              <a:off x="1439672" y="296093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40"/>
            <p:cNvCxnSpPr/>
            <p:nvPr/>
          </p:nvCxnSpPr>
          <p:spPr>
            <a:xfrm>
              <a:off x="1439672" y="327539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1439672" y="389704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1475992" y="4854213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1116000" y="4140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0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1116000" y="804141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1116000" y="1278000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1188000" y="1728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188000" y="2268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188000" y="2844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1188000" y="3150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1188000" y="37692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1224000" y="4725144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55" name="Gerade Verbindung mit Pfeil 54"/>
            <p:cNvCxnSpPr/>
            <p:nvPr/>
          </p:nvCxnSpPr>
          <p:spPr>
            <a:xfrm flipH="1">
              <a:off x="6912000" y="2491127"/>
              <a:ext cx="720000" cy="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feld 56"/>
            <p:cNvSpPr txBox="1"/>
            <p:nvPr/>
          </p:nvSpPr>
          <p:spPr>
            <a:xfrm>
              <a:off x="7560000" y="2340000"/>
              <a:ext cx="15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509)</a:t>
              </a:r>
            </a:p>
          </p:txBody>
        </p:sp>
        <p:cxnSp>
          <p:nvCxnSpPr>
            <p:cNvPr id="58" name="Gerade Verbindung mit Pfeil 57"/>
            <p:cNvCxnSpPr/>
            <p:nvPr/>
          </p:nvCxnSpPr>
          <p:spPr>
            <a:xfrm flipH="1">
              <a:off x="4435720" y="612304"/>
              <a:ext cx="388816" cy="584448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Gerade Verbindung mit Pfeil 58"/>
            <p:cNvCxnSpPr/>
            <p:nvPr/>
          </p:nvCxnSpPr>
          <p:spPr>
            <a:xfrm>
              <a:off x="3888432" y="612304"/>
              <a:ext cx="468088" cy="576064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feld 60"/>
            <p:cNvSpPr txBox="1"/>
            <p:nvPr/>
          </p:nvSpPr>
          <p:spPr>
            <a:xfrm>
              <a:off x="4716000" y="432000"/>
              <a:ext cx="16916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274)</a:t>
              </a: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3132000" y="376535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</a:t>
              </a:r>
              <a:r>
                <a:rPr lang="en-US" sz="1200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63266)</a:t>
              </a: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116000" y="108000"/>
              <a:ext cx="5044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</p:txBody>
        </p:sp>
      </p:grpSp>
      <p:sp>
        <p:nvSpPr>
          <p:cNvPr id="53" name="Textfeld 52"/>
          <p:cNvSpPr txBox="1"/>
          <p:nvPr/>
        </p:nvSpPr>
        <p:spPr>
          <a:xfrm>
            <a:off x="431896" y="-48410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i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1">
            <a:extLst>
              <a:ext uri="{FF2B5EF4-FFF2-40B4-BE49-F238E27FC236}">
                <a16:creationId xmlns:a16="http://schemas.microsoft.com/office/drawing/2014/main" id="{A5D22CAD-308B-4369-8AFB-F62E0FC17E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B98EDC07-B8CB-4280-B882-9F5B55546A2E}"/>
              </a:ext>
            </a:extLst>
          </p:cNvPr>
          <p:cNvCxnSpPr>
            <a:cxnSpLocks/>
          </p:cNvCxnSpPr>
          <p:nvPr/>
        </p:nvCxnSpPr>
        <p:spPr>
          <a:xfrm>
            <a:off x="1692000" y="290144"/>
            <a:ext cx="572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0201FCCC-0007-4EFD-9457-A060D71B53F5}"/>
              </a:ext>
            </a:extLst>
          </p:cNvPr>
          <p:cNvCxnSpPr/>
          <p:nvPr/>
        </p:nvCxnSpPr>
        <p:spPr>
          <a:xfrm>
            <a:off x="1188000" y="344144"/>
            <a:ext cx="0" cy="464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ieren 16"/>
          <p:cNvGrpSpPr/>
          <p:nvPr/>
        </p:nvGrpSpPr>
        <p:grpSpPr>
          <a:xfrm>
            <a:off x="1763688" y="-288000"/>
            <a:ext cx="7128544" cy="5805232"/>
            <a:chOff x="1763688" y="-288000"/>
            <a:chExt cx="7128544" cy="580523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835696" y="251740"/>
              <a:ext cx="5328592" cy="483344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" name="Textfeld 4"/>
            <p:cNvSpPr txBox="1"/>
            <p:nvPr/>
          </p:nvSpPr>
          <p:spPr>
            <a:xfrm>
              <a:off x="1763688" y="-36000"/>
              <a:ext cx="504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624000" y="-36000"/>
              <a:ext cx="468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499992" y="-288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580000" y="-3600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Gerade Verbindung mit Pfeil 8"/>
            <p:cNvCxnSpPr/>
            <p:nvPr/>
          </p:nvCxnSpPr>
          <p:spPr>
            <a:xfrm flipH="1">
              <a:off x="5724128" y="1052736"/>
              <a:ext cx="216024" cy="864096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Gerade Verbindung mit Pfeil 9"/>
            <p:cNvCxnSpPr/>
            <p:nvPr/>
          </p:nvCxnSpPr>
          <p:spPr>
            <a:xfrm>
              <a:off x="5436000" y="828000"/>
              <a:ext cx="144016" cy="108012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feld 10"/>
            <p:cNvSpPr txBox="1"/>
            <p:nvPr/>
          </p:nvSpPr>
          <p:spPr>
            <a:xfrm>
              <a:off x="5724128" y="847745"/>
              <a:ext cx="16916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409)</a:t>
              </a: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4932040" y="620688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408)</a:t>
              </a:r>
            </a:p>
          </p:txBody>
        </p:sp>
        <p:cxnSp>
          <p:nvCxnSpPr>
            <p:cNvPr id="13" name="Gerade Verbindung mit Pfeil 12"/>
            <p:cNvCxnSpPr/>
            <p:nvPr/>
          </p:nvCxnSpPr>
          <p:spPr>
            <a:xfrm flipH="1">
              <a:off x="6660232" y="2492872"/>
              <a:ext cx="720000" cy="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7308232" y="2348880"/>
              <a:ext cx="15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495)</a:t>
              </a: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2987824" y="5024789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on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l2-303a-G300</a:t>
              </a:r>
            </a:p>
          </p:txBody>
        </p:sp>
      </p:grpSp>
      <p:sp>
        <p:nvSpPr>
          <p:cNvPr id="16" name="Textfeld 15"/>
          <p:cNvSpPr txBox="1"/>
          <p:nvPr/>
        </p:nvSpPr>
        <p:spPr>
          <a:xfrm>
            <a:off x="791580" y="-67334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</a:t>
            </a:r>
          </a:p>
        </p:txBody>
      </p:sp>
      <p:sp>
        <p:nvSpPr>
          <p:cNvPr id="18" name="Rectangle 1">
            <a:extLst>
              <a:ext uri="{FF2B5EF4-FFF2-40B4-BE49-F238E27FC236}">
                <a16:creationId xmlns:a16="http://schemas.microsoft.com/office/drawing/2014/main" id="{74612348-85E6-4E8D-B040-A9BE008992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A540F479-75FC-49A5-964E-02842551BF82}"/>
              </a:ext>
            </a:extLst>
          </p:cNvPr>
          <p:cNvCxnSpPr>
            <a:cxnSpLocks/>
          </p:cNvCxnSpPr>
          <p:nvPr/>
        </p:nvCxnSpPr>
        <p:spPr>
          <a:xfrm>
            <a:off x="1836000" y="198000"/>
            <a:ext cx="532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D253124-B408-4EFF-ABC7-7931CB4E17CE}"/>
              </a:ext>
            </a:extLst>
          </p:cNvPr>
          <p:cNvCxnSpPr/>
          <p:nvPr/>
        </p:nvCxnSpPr>
        <p:spPr>
          <a:xfrm>
            <a:off x="1764000" y="252000"/>
            <a:ext cx="0" cy="48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9B2E8EBE-1B68-4BD5-9B77-AEEDD1D3A941}"/>
              </a:ext>
            </a:extLst>
          </p:cNvPr>
          <p:cNvSpPr/>
          <p:nvPr/>
        </p:nvSpPr>
        <p:spPr>
          <a:xfrm>
            <a:off x="1331030" y="246316"/>
            <a:ext cx="3978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4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n-GB" sz="14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uppieren 34"/>
          <p:cNvGrpSpPr/>
          <p:nvPr/>
        </p:nvGrpSpPr>
        <p:grpSpPr>
          <a:xfrm>
            <a:off x="1439720" y="-180000"/>
            <a:ext cx="7596776" cy="5697232"/>
            <a:chOff x="1439720" y="-180000"/>
            <a:chExt cx="7596776" cy="5697232"/>
          </a:xfrm>
        </p:grpSpPr>
        <p:pic>
          <p:nvPicPr>
            <p:cNvPr id="5" name="Grafik 4" descr="Gel 2 4th DIGE B silver-stain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024884" y="332656"/>
              <a:ext cx="5355428" cy="4752528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1979712" y="72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804000" y="72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536000" y="-180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760000" y="7200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Gerade Verbindung 35"/>
            <p:cNvCxnSpPr/>
            <p:nvPr/>
          </p:nvCxnSpPr>
          <p:spPr>
            <a:xfrm>
              <a:off x="1763392" y="53418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36"/>
            <p:cNvCxnSpPr/>
            <p:nvPr/>
          </p:nvCxnSpPr>
          <p:spPr>
            <a:xfrm>
              <a:off x="1763392" y="93014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37"/>
            <p:cNvCxnSpPr/>
            <p:nvPr/>
          </p:nvCxnSpPr>
          <p:spPr>
            <a:xfrm>
              <a:off x="1763720" y="1404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1763392" y="1908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39"/>
            <p:cNvCxnSpPr/>
            <p:nvPr/>
          </p:nvCxnSpPr>
          <p:spPr>
            <a:xfrm>
              <a:off x="1763392" y="2448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40"/>
            <p:cNvCxnSpPr/>
            <p:nvPr/>
          </p:nvCxnSpPr>
          <p:spPr>
            <a:xfrm>
              <a:off x="1763392" y="3024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1763392" y="3348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1764000" y="3960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43"/>
            <p:cNvCxnSpPr/>
            <p:nvPr/>
          </p:nvCxnSpPr>
          <p:spPr>
            <a:xfrm>
              <a:off x="1764000" y="4854213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feld 44"/>
            <p:cNvSpPr txBox="1"/>
            <p:nvPr/>
          </p:nvSpPr>
          <p:spPr>
            <a:xfrm>
              <a:off x="1439720" y="4140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0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1439720" y="804141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1439720" y="1278000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511720" y="1782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511720" y="2304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1511720" y="2880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1511720" y="3222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1511720" y="3834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1512000" y="4725144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sp>
          <p:nvSpPr>
            <p:cNvPr id="85" name="Textfeld 84"/>
            <p:cNvSpPr txBox="1"/>
            <p:nvPr/>
          </p:nvSpPr>
          <p:spPr>
            <a:xfrm>
              <a:off x="2987824" y="5024789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on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lver-stained Gel 2</a:t>
              </a:r>
            </a:p>
          </p:txBody>
        </p:sp>
        <p:cxnSp>
          <p:nvCxnSpPr>
            <p:cNvPr id="86" name="Gerade Verbindung mit Pfeil 85"/>
            <p:cNvCxnSpPr/>
            <p:nvPr/>
          </p:nvCxnSpPr>
          <p:spPr>
            <a:xfrm flipH="1">
              <a:off x="5922000" y="1052736"/>
              <a:ext cx="216024" cy="936104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Gerade Verbindung mit Pfeil 86"/>
            <p:cNvCxnSpPr/>
            <p:nvPr/>
          </p:nvCxnSpPr>
          <p:spPr>
            <a:xfrm>
              <a:off x="5652024" y="828000"/>
              <a:ext cx="144112" cy="116084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feld 87"/>
            <p:cNvSpPr txBox="1"/>
            <p:nvPr/>
          </p:nvSpPr>
          <p:spPr>
            <a:xfrm>
              <a:off x="5940152" y="847745"/>
              <a:ext cx="16916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409)</a:t>
              </a: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5148064" y="620688"/>
              <a:ext cx="1080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r</a:t>
              </a:r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408)</a:t>
              </a:r>
            </a:p>
          </p:txBody>
        </p:sp>
        <p:cxnSp>
          <p:nvCxnSpPr>
            <p:cNvPr id="91" name="Gerade Verbindung mit Pfeil 90"/>
            <p:cNvCxnSpPr/>
            <p:nvPr/>
          </p:nvCxnSpPr>
          <p:spPr>
            <a:xfrm flipH="1">
              <a:off x="6804328" y="2556000"/>
              <a:ext cx="720000" cy="0"/>
            </a:xfrm>
            <a:prstGeom prst="straightConnector1">
              <a:avLst/>
            </a:prstGeom>
            <a:ln w="254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feld 91"/>
            <p:cNvSpPr txBox="1"/>
            <p:nvPr/>
          </p:nvSpPr>
          <p:spPr>
            <a:xfrm>
              <a:off x="7452496" y="2412000"/>
              <a:ext cx="158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495)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440000" y="108000"/>
              <a:ext cx="5040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</p:txBody>
        </p:sp>
      </p:grpSp>
      <p:sp>
        <p:nvSpPr>
          <p:cNvPr id="34" name="Textfeld 33"/>
          <p:cNvSpPr txBox="1"/>
          <p:nvPr/>
        </p:nvSpPr>
        <p:spPr>
          <a:xfrm>
            <a:off x="971600" y="-77906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i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1">
            <a:extLst>
              <a:ext uri="{FF2B5EF4-FFF2-40B4-BE49-F238E27FC236}">
                <a16:creationId xmlns:a16="http://schemas.microsoft.com/office/drawing/2014/main" id="{050B550A-4F67-4B32-8574-80F19DC9D1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9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CBEF937E-AA27-40A2-B5DC-8033DFA038AA}"/>
              </a:ext>
            </a:extLst>
          </p:cNvPr>
          <p:cNvCxnSpPr>
            <a:cxnSpLocks/>
          </p:cNvCxnSpPr>
          <p:nvPr/>
        </p:nvCxnSpPr>
        <p:spPr>
          <a:xfrm>
            <a:off x="2052000" y="290144"/>
            <a:ext cx="536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2267C34C-14C3-4B13-89C9-2AD93225ECD0}"/>
              </a:ext>
            </a:extLst>
          </p:cNvPr>
          <p:cNvCxnSpPr/>
          <p:nvPr/>
        </p:nvCxnSpPr>
        <p:spPr>
          <a:xfrm>
            <a:off x="1512000" y="342754"/>
            <a:ext cx="0" cy="47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71</Words>
  <Application>Microsoft Office PowerPoint</Application>
  <PresentationFormat>On-screen Show (4:3)</PresentationFormat>
  <Paragraphs>75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dobe Devanagari</vt:lpstr>
      <vt:lpstr>Arial</vt:lpstr>
      <vt:lpstr>Calibri</vt:lpstr>
      <vt:lpstr>Times New Roman</vt:lpstr>
      <vt:lpstr>Larissa-Design</vt:lpstr>
      <vt:lpstr>PowerPoint Presentation</vt:lpstr>
      <vt:lpstr>PowerPoint Presentation</vt:lpstr>
      <vt:lpstr>PowerPoint Presentation</vt:lpstr>
      <vt:lpstr>PowerPoint Presentation</vt:lpstr>
    </vt:vector>
  </TitlesOfParts>
  <Company>Veterinärmedizinische 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onoyiosa</dc:creator>
  <cp:lastModifiedBy>Andreas Monoyios</cp:lastModifiedBy>
  <cp:revision>43</cp:revision>
  <dcterms:created xsi:type="dcterms:W3CDTF">2017-08-31T12:41:23Z</dcterms:created>
  <dcterms:modified xsi:type="dcterms:W3CDTF">2018-11-04T18:58:41Z</dcterms:modified>
</cp:coreProperties>
</file>